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9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iciani, Elvis" initials="TE" lastIdx="4" clrIdx="0">
    <p:extLst>
      <p:ext uri="{19B8F6BF-5375-455C-9EA6-DF929625EA0E}">
        <p15:presenceInfo xmlns:p15="http://schemas.microsoft.com/office/powerpoint/2012/main" userId="S::ticianie@msu.edu::497841fe-bd8a-479a-afe0-916b690c3487" providerId="AD"/>
      </p:ext>
    </p:extLst>
  </p:cmAuthor>
  <p:cmAuthor id="2" name="Veiga-Lopez, Almudena" initials="VLA" lastIdx="9" clrIdx="1">
    <p:extLst>
      <p:ext uri="{19B8F6BF-5375-455C-9EA6-DF929625EA0E}">
        <p15:presenceInfo xmlns:p15="http://schemas.microsoft.com/office/powerpoint/2012/main" userId="S::veiga@msu.edu::75c38618-c118-4518-9108-7999939153c7" providerId="AD"/>
      </p:ext>
    </p:extLst>
  </p:cmAuthor>
  <p:cmAuthor id="3" name="Veiga-Lopez, Almudena" initials="VLA [2]" lastIdx="27" clrIdx="2">
    <p:extLst>
      <p:ext uri="{19B8F6BF-5375-455C-9EA6-DF929625EA0E}">
        <p15:presenceInfo xmlns:p15="http://schemas.microsoft.com/office/powerpoint/2012/main" userId="Veiga-Lopez, Almudena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50" autoAdjust="0"/>
    <p:restoredTop sz="94660"/>
  </p:normalViewPr>
  <p:slideViewPr>
    <p:cSldViewPr snapToGrid="0">
      <p:cViewPr>
        <p:scale>
          <a:sx n="125" d="100"/>
          <a:sy n="125" d="100"/>
        </p:scale>
        <p:origin x="1061" y="-9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9B8944-271E-411C-B67E-5BBAF78B1640}" type="datetimeFigureOut">
              <a:rPr lang="en-US" smtClean="0"/>
              <a:t>1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DE7044-24F5-44AE-9B69-CE29DF521A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83418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9B8944-271E-411C-B67E-5BBAF78B1640}" type="datetimeFigureOut">
              <a:rPr lang="en-US" smtClean="0"/>
              <a:t>1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DE7044-24F5-44AE-9B69-CE29DF521A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83062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9B8944-271E-411C-B67E-5BBAF78B1640}" type="datetimeFigureOut">
              <a:rPr lang="en-US" smtClean="0"/>
              <a:t>1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DE7044-24F5-44AE-9B69-CE29DF521A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23391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9B8944-271E-411C-B67E-5BBAF78B1640}" type="datetimeFigureOut">
              <a:rPr lang="en-US" smtClean="0"/>
              <a:t>1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DE7044-24F5-44AE-9B69-CE29DF521A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81993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9B8944-271E-411C-B67E-5BBAF78B1640}" type="datetimeFigureOut">
              <a:rPr lang="en-US" smtClean="0"/>
              <a:t>1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DE7044-24F5-44AE-9B69-CE29DF521A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3394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9B8944-271E-411C-B67E-5BBAF78B1640}" type="datetimeFigureOut">
              <a:rPr lang="en-US" smtClean="0"/>
              <a:t>1/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DE7044-24F5-44AE-9B69-CE29DF521A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59106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9B8944-271E-411C-B67E-5BBAF78B1640}" type="datetimeFigureOut">
              <a:rPr lang="en-US" smtClean="0"/>
              <a:t>1/8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DE7044-24F5-44AE-9B69-CE29DF521A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55264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9B8944-271E-411C-B67E-5BBAF78B1640}" type="datetimeFigureOut">
              <a:rPr lang="en-US" smtClean="0"/>
              <a:t>1/8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DE7044-24F5-44AE-9B69-CE29DF521A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29319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9B8944-271E-411C-B67E-5BBAF78B1640}" type="datetimeFigureOut">
              <a:rPr lang="en-US" smtClean="0"/>
              <a:t>1/8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DE7044-24F5-44AE-9B69-CE29DF521A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9394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9B8944-271E-411C-B67E-5BBAF78B1640}" type="datetimeFigureOut">
              <a:rPr lang="en-US" smtClean="0"/>
              <a:t>1/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DE7044-24F5-44AE-9B69-CE29DF521A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23626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9B8944-271E-411C-B67E-5BBAF78B1640}" type="datetimeFigureOut">
              <a:rPr lang="en-US" smtClean="0"/>
              <a:t>1/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DE7044-24F5-44AE-9B69-CE29DF521A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17365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9B8944-271E-411C-B67E-5BBAF78B1640}" type="datetimeFigureOut">
              <a:rPr lang="en-US" smtClean="0"/>
              <a:t>1/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DE7044-24F5-44AE-9B69-CE29DF521A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02857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665128C9-C52E-4D1F-8A1F-0C44C8228E1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09066673"/>
              </p:ext>
            </p:extLst>
          </p:nvPr>
        </p:nvGraphicFramePr>
        <p:xfrm>
          <a:off x="586988" y="1285061"/>
          <a:ext cx="5758056" cy="4088475"/>
        </p:xfrm>
        <a:graphic>
          <a:graphicData uri="http://schemas.openxmlformats.org/drawingml/2006/table">
            <a:tbl>
              <a:tblPr firstRow="1" firstCol="1" bandRow="1">
                <a:tableStyleId>{F5AB1C69-6EDB-4FF4-983F-18BD219EF322}</a:tableStyleId>
              </a:tblPr>
              <a:tblGrid>
                <a:gridCol w="794583">
                  <a:extLst>
                    <a:ext uri="{9D8B030D-6E8A-4147-A177-3AD203B41FA5}">
                      <a16:colId xmlns:a16="http://schemas.microsoft.com/office/drawing/2014/main" val="830626738"/>
                    </a:ext>
                  </a:extLst>
                </a:gridCol>
                <a:gridCol w="1232089">
                  <a:extLst>
                    <a:ext uri="{9D8B030D-6E8A-4147-A177-3AD203B41FA5}">
                      <a16:colId xmlns:a16="http://schemas.microsoft.com/office/drawing/2014/main" val="4201787592"/>
                    </a:ext>
                  </a:extLst>
                </a:gridCol>
                <a:gridCol w="541020">
                  <a:extLst>
                    <a:ext uri="{9D8B030D-6E8A-4147-A177-3AD203B41FA5}">
                      <a16:colId xmlns:a16="http://schemas.microsoft.com/office/drawing/2014/main" val="1772843840"/>
                    </a:ext>
                  </a:extLst>
                </a:gridCol>
                <a:gridCol w="491769">
                  <a:extLst>
                    <a:ext uri="{9D8B030D-6E8A-4147-A177-3AD203B41FA5}">
                      <a16:colId xmlns:a16="http://schemas.microsoft.com/office/drawing/2014/main" val="3978071221"/>
                    </a:ext>
                  </a:extLst>
                </a:gridCol>
                <a:gridCol w="2698595">
                  <a:extLst>
                    <a:ext uri="{9D8B030D-6E8A-4147-A177-3AD203B41FA5}">
                      <a16:colId xmlns:a16="http://schemas.microsoft.com/office/drawing/2014/main" val="2227800325"/>
                    </a:ext>
                  </a:extLst>
                </a:gridCol>
              </a:tblGrid>
              <a:tr h="180574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ype</a:t>
                      </a:r>
                      <a:endParaRPr lang="es-ES" sz="9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4866" marR="6486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body</a:t>
                      </a:r>
                      <a:endParaRPr lang="es-ES" sz="9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4866" marR="6486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lution</a:t>
                      </a:r>
                      <a:endParaRPr lang="es-ES" sz="9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4866" marR="6486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ost</a:t>
                      </a:r>
                      <a:endParaRPr lang="es-ES" sz="9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4866" marR="6486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alog # (company)</a:t>
                      </a:r>
                      <a:endParaRPr lang="es-ES" sz="9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4866" marR="64866" marT="0" marB="0"/>
                </a:tc>
                <a:extLst>
                  <a:ext uri="{0D108BD9-81ED-4DB2-BD59-A6C34878D82A}">
                    <a16:rowId xmlns:a16="http://schemas.microsoft.com/office/drawing/2014/main" val="4242547425"/>
                  </a:ext>
                </a:extLst>
              </a:tr>
              <a:tr h="361147">
                <a:tc rowSpan="7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ary antibody</a:t>
                      </a:r>
                      <a:endParaRPr lang="es-ES" sz="9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25826" marR="2582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KT</a:t>
                      </a:r>
                      <a:endParaRPr lang="es-ES" sz="9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5826" marR="2582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:1,000</a:t>
                      </a:r>
                      <a:endParaRPr lang="es-ES" sz="9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5826" marR="2582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Rabbit</a:t>
                      </a:r>
                      <a:endParaRPr lang="es-ES" sz="9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5826" marR="2582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9272S (Cell Signaling Technology)</a:t>
                      </a:r>
                      <a:endParaRPr lang="es-ES" sz="9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5826" marR="25826" marT="0" marB="0"/>
                </a:tc>
                <a:extLst>
                  <a:ext uri="{0D108BD9-81ED-4DB2-BD59-A6C34878D82A}">
                    <a16:rowId xmlns:a16="http://schemas.microsoft.com/office/drawing/2014/main" val="3139501329"/>
                  </a:ext>
                </a:extLst>
              </a:tr>
              <a:tr h="361147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EGFR</a:t>
                      </a:r>
                      <a:endParaRPr lang="es-ES" sz="9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5826" marR="2582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:1,000</a:t>
                      </a:r>
                      <a:endParaRPr lang="es-ES" sz="9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5826" marR="2582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Rabbit</a:t>
                      </a:r>
                      <a:endParaRPr lang="es-ES" sz="9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5826" marR="2582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B32077 (Abcam)</a:t>
                      </a:r>
                      <a:endParaRPr lang="es-ES" sz="9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5826" marR="25826" marT="0" marB="0"/>
                </a:tc>
                <a:extLst>
                  <a:ext uri="{0D108BD9-81ED-4DB2-BD59-A6C34878D82A}">
                    <a16:rowId xmlns:a16="http://schemas.microsoft.com/office/drawing/2014/main" val="2693141267"/>
                  </a:ext>
                </a:extLst>
              </a:tr>
              <a:tr h="361147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ERK </a:t>
                      </a:r>
                      <a:endParaRPr lang="es-ES" sz="9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5826" marR="2582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:1,000</a:t>
                      </a:r>
                      <a:endParaRPr lang="es-ES" sz="9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5826" marR="2582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Rabbit</a:t>
                      </a:r>
                      <a:endParaRPr lang="es-ES" sz="9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5826" marR="2582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B17942 (Abcam)</a:t>
                      </a:r>
                      <a:endParaRPr lang="es-ES" sz="9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5826" marR="25826" marT="0" marB="0"/>
                </a:tc>
                <a:extLst>
                  <a:ext uri="{0D108BD9-81ED-4DB2-BD59-A6C34878D82A}">
                    <a16:rowId xmlns:a16="http://schemas.microsoft.com/office/drawing/2014/main" val="2420665046"/>
                  </a:ext>
                </a:extLst>
              </a:tr>
              <a:tr h="361147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s-ES" sz="9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hospho-Akt</a:t>
                      </a:r>
                      <a:r>
                        <a:rPr lang="es-E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(Tyr 204)</a:t>
                      </a:r>
                    </a:p>
                  </a:txBody>
                  <a:tcPr marL="25826" marR="2582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:1,000</a:t>
                      </a:r>
                      <a:endParaRPr lang="es-ES" sz="9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5826" marR="2582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Rabbit</a:t>
                      </a:r>
                      <a:endParaRPr lang="es-ES" sz="9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5826" marR="2582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9271S (Cell Signaling Technology)</a:t>
                      </a:r>
                      <a:endParaRPr lang="es-ES" sz="9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5826" marR="25826" marT="0" marB="0"/>
                </a:tc>
                <a:extLst>
                  <a:ext uri="{0D108BD9-81ED-4DB2-BD59-A6C34878D82A}">
                    <a16:rowId xmlns:a16="http://schemas.microsoft.com/office/drawing/2014/main" val="2786477859"/>
                  </a:ext>
                </a:extLst>
              </a:tr>
              <a:tr h="361147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hospho-EGFR </a:t>
                      </a:r>
                      <a:endParaRPr lang="es-ES" sz="9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5826" marR="2582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:1,000</a:t>
                      </a:r>
                      <a:endParaRPr lang="es-ES" sz="9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5826" marR="2582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Rabbit</a:t>
                      </a:r>
                      <a:endParaRPr lang="es-ES" sz="9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5826" marR="2582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777S (Cell Signaling Technology)</a:t>
                      </a:r>
                      <a:endParaRPr lang="es-ES" sz="9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5826" marR="25826" marT="0" marB="0"/>
                </a:tc>
                <a:extLst>
                  <a:ext uri="{0D108BD9-81ED-4DB2-BD59-A6C34878D82A}">
                    <a16:rowId xmlns:a16="http://schemas.microsoft.com/office/drawing/2014/main" val="3630970708"/>
                  </a:ext>
                </a:extLst>
              </a:tr>
              <a:tr h="361147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hospho-p44/42 MAPK </a:t>
                      </a:r>
                      <a:endParaRPr lang="es-ES" sz="9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5826" marR="2582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:1,000</a:t>
                      </a:r>
                      <a:endParaRPr lang="es-ES" sz="9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5826" marR="2582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Rabbit</a:t>
                      </a:r>
                      <a:endParaRPr lang="es-ES" sz="9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5826" marR="2582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4370S (Cell Signaling Technology)</a:t>
                      </a:r>
                      <a:endParaRPr lang="es-ES" sz="9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5826" marR="25826" marT="0" marB="0"/>
                </a:tc>
                <a:extLst>
                  <a:ext uri="{0D108BD9-81ED-4DB2-BD59-A6C34878D82A}">
                    <a16:rowId xmlns:a16="http://schemas.microsoft.com/office/drawing/2014/main" val="3380754047"/>
                  </a:ext>
                </a:extLst>
              </a:tr>
              <a:tr h="361147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β-Actin</a:t>
                      </a:r>
                      <a:endParaRPr lang="es-ES" sz="9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5826" marR="2582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:5,000</a:t>
                      </a:r>
                      <a:endParaRPr lang="es-ES" sz="9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5826" marR="2582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ouse</a:t>
                      </a:r>
                      <a:endParaRPr lang="es-ES" sz="9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5826" marR="2582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1978 (</a:t>
                      </a:r>
                      <a:r>
                        <a:rPr lang="en-US" sz="9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illiporeSigma</a:t>
                      </a: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)</a:t>
                      </a:r>
                      <a:endParaRPr lang="es-ES" sz="9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5826" marR="25826" marT="0" marB="0"/>
                </a:tc>
                <a:extLst>
                  <a:ext uri="{0D108BD9-81ED-4DB2-BD59-A6C34878D82A}">
                    <a16:rowId xmlns:a16="http://schemas.microsoft.com/office/drawing/2014/main" val="3409953648"/>
                  </a:ext>
                </a:extLst>
              </a:tr>
              <a:tr h="731362">
                <a:tc rowSpan="2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condary antibody</a:t>
                      </a:r>
                      <a:endParaRPr lang="es-ES" sz="9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25826" marR="2582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oat anti-mouse HRP-conjugated</a:t>
                      </a:r>
                      <a:endParaRPr lang="es-ES" sz="9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5826" marR="2582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:5,000</a:t>
                      </a:r>
                      <a:endParaRPr lang="es-ES" sz="9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5826" marR="2582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oat</a:t>
                      </a:r>
                      <a:endParaRPr lang="es-ES" sz="9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5826" marR="2582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15-005-003 (Jackson </a:t>
                      </a:r>
                      <a:r>
                        <a:rPr lang="en-US" sz="9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Immunoresearch</a:t>
                      </a: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)</a:t>
                      </a:r>
                      <a:endParaRPr lang="es-ES" sz="9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5826" marR="25826" marT="0" marB="0"/>
                </a:tc>
                <a:extLst>
                  <a:ext uri="{0D108BD9-81ED-4DB2-BD59-A6C34878D82A}">
                    <a16:rowId xmlns:a16="http://schemas.microsoft.com/office/drawing/2014/main" val="4076805446"/>
                  </a:ext>
                </a:extLst>
              </a:tr>
              <a:tr h="546255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oat anti-rabbit HRP-conjugated</a:t>
                      </a:r>
                      <a:endParaRPr lang="es-ES" sz="9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5826" marR="2582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:5,000</a:t>
                      </a:r>
                      <a:endParaRPr lang="es-ES" sz="9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5826" marR="2582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oat</a:t>
                      </a:r>
                      <a:endParaRPr lang="es-ES" sz="9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5826" marR="2582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11-005-003 (Jackson </a:t>
                      </a:r>
                      <a:r>
                        <a:rPr lang="en-US" sz="900" kern="1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Immunoresearch</a:t>
                      </a:r>
                      <a:r>
                        <a:rPr lang="en-US" sz="9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)</a:t>
                      </a:r>
                      <a:endParaRPr lang="es-ES" sz="9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25826" marR="25826" marT="0" marB="0"/>
                </a:tc>
                <a:extLst>
                  <a:ext uri="{0D108BD9-81ED-4DB2-BD59-A6C34878D82A}">
                    <a16:rowId xmlns:a16="http://schemas.microsoft.com/office/drawing/2014/main" val="1896131968"/>
                  </a:ext>
                </a:extLst>
              </a:tr>
            </a:tbl>
          </a:graphicData>
        </a:graphic>
      </p:graphicFrame>
      <p:sp>
        <p:nvSpPr>
          <p:cNvPr id="7" name="Rectangle 2">
            <a:extLst>
              <a:ext uri="{FF2B5EF4-FFF2-40B4-BE49-F238E27FC236}">
                <a16:creationId xmlns:a16="http://schemas.microsoft.com/office/drawing/2014/main" id="{6AC63A50-DFB0-49C5-80CA-197BDE32B42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7778" y="640640"/>
            <a:ext cx="5847266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仿宋" charset="-122"/>
                <a:cs typeface="Arial" panose="020B0604020202020204" pitchFamily="34" charset="0"/>
              </a:rPr>
              <a:t>Supplemental </a:t>
            </a:r>
            <a:r>
              <a:rPr kumimoji="0" lang="en-US" altLang="zh-CN" sz="12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仿宋" charset="-122"/>
                <a:cs typeface="Arial" panose="020B0604020202020204" pitchFamily="34" charset="0"/>
              </a:rPr>
              <a:t>Table S1</a:t>
            </a:r>
            <a:r>
              <a:rPr kumimoji="0" lang="en-US" altLang="zh-CN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仿宋" charset="-122"/>
                <a:cs typeface="Arial" panose="020B0604020202020204" pitchFamily="34" charset="0"/>
              </a:rPr>
              <a:t>. </a:t>
            </a:r>
            <a:r>
              <a:rPr kumimoji="0" lang="en-US" altLang="zh-CN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仿宋" charset="-122"/>
                <a:cs typeface="Arial" panose="020B0604020202020204" pitchFamily="34" charset="0"/>
              </a:rPr>
              <a:t>Antibodies used for western blot</a:t>
            </a:r>
            <a:endParaRPr kumimoji="0" lang="es-ES" altLang="zh-CN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仿宋" charset="-122"/>
                <a:cs typeface="Arial" panose="020B0604020202020204" pitchFamily="34" charset="0"/>
              </a:rPr>
              <a:t> </a:t>
            </a:r>
            <a:endParaRPr kumimoji="0" lang="es-ES" altLang="zh-CN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200" b="0" i="0" u="none" strike="noStrike" cap="none" normalizeH="0" baseline="0" dirty="0">
                <a:ln>
                  <a:noFill/>
                </a:ln>
                <a:solidFill>
                  <a:srgbClr val="FFFFFF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F: immunofluorescence, WB: western blotting</a:t>
            </a:r>
            <a:endParaRPr kumimoji="0" lang="en-US" altLang="zh-CN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342017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2432</TotalTime>
  <Words>113</Words>
  <Application>Microsoft Office PowerPoint</Application>
  <PresentationFormat>On-screen Show (4:3)</PresentationFormat>
  <Paragraphs>4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iciani, Elvis</dc:creator>
  <cp:lastModifiedBy>MDPI</cp:lastModifiedBy>
  <cp:revision>282</cp:revision>
  <dcterms:created xsi:type="dcterms:W3CDTF">2019-12-05T21:01:15Z</dcterms:created>
  <dcterms:modified xsi:type="dcterms:W3CDTF">2022-01-08T09:08:07Z</dcterms:modified>
</cp:coreProperties>
</file>